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320F7"/>
    <a:srgbClr val="4609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979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38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79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681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230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379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66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927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602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993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14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488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698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4E953-A531-4033-8E8A-CE53969B0436}" type="datetimeFigureOut">
              <a:rPr lang="en-US" smtClean="0"/>
              <a:t>7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2EC0F5-8F76-49C0-A3B8-ED3CDAD32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747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2F2BCE9-7AEF-4BD9-92A7-5FAA71496C31}"/>
              </a:ext>
            </a:extLst>
          </p:cNvPr>
          <p:cNvSpPr txBox="1"/>
          <p:nvPr/>
        </p:nvSpPr>
        <p:spPr>
          <a:xfrm>
            <a:off x="891071" y="14515"/>
            <a:ext cx="9136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320F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: L3-L5 vertebrae µCT analysi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21B4FBE-D588-EE71-1D32-4B3C2753A6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916" y="353260"/>
            <a:ext cx="8109310" cy="497702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FB73CB8-C7B6-2760-7BFD-F9969A331B65}"/>
              </a:ext>
            </a:extLst>
          </p:cNvPr>
          <p:cNvSpPr txBox="1"/>
          <p:nvPr/>
        </p:nvSpPr>
        <p:spPr>
          <a:xfrm>
            <a:off x="617635" y="5368836"/>
            <a:ext cx="793469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upplementary Figure 1. Micro-CT analysis of L3-L5 vertebrae shows diet did not significantly impact bone quantity or quality. (A) Representative images of quantitative micro-CT analysis of L3-L5 vertebrae from four different dietary groups. (B) Bone volume/tissue volume, BV/TV (%); (C) Total tissue volume, TV (mm3); (D) Total bone volume, BV (mm3); (E) Bone surface / tissue volume, BS/TV (1/mm); (F) Trabecular thickness, Tb. Th (mm); (G) Trabecular number, Tb. N (no./mm); (H) Trabecular spacing, Tb. </a:t>
            </a:r>
            <a:r>
              <a:rPr lang="en-US" sz="1200" dirty="0" err="1"/>
              <a:t>Sp</a:t>
            </a:r>
            <a:r>
              <a:rPr lang="en-US" sz="1200" dirty="0"/>
              <a:t> (mm); (I) Bone mineral density, BMD (g/cm3). Data are expressed as mean +/- SD (N = 9). For two-way ANOVA, followed by Student-Newman-Keuls post hoc analysis for multiple comparisons *P ≤ 0.05, **P ≤ 0.01, ***P ≤ 0.001, **** P ≤ 0.0001.</a:t>
            </a:r>
          </a:p>
        </p:txBody>
      </p:sp>
    </p:spTree>
    <p:extLst>
      <p:ext uri="{BB962C8B-B14F-4D97-AF65-F5344CB8AC3E}">
        <p14:creationId xmlns:p14="http://schemas.microsoft.com/office/powerpoint/2010/main" val="1172438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83</TotalTime>
  <Words>19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Jin-Ran</dc:creator>
  <cp:lastModifiedBy>Chen, Jin-Ran</cp:lastModifiedBy>
  <cp:revision>290</cp:revision>
  <dcterms:created xsi:type="dcterms:W3CDTF">2021-04-02T00:07:01Z</dcterms:created>
  <dcterms:modified xsi:type="dcterms:W3CDTF">2025-07-17T17:41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3-04-27T15:41:57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e98da80a-25e0-4fda-8bc8-7b9c56a200d5</vt:lpwstr>
  </property>
  <property fmtid="{D5CDD505-2E9C-101B-9397-08002B2CF9AE}" pid="8" name="MSIP_Label_8ca390d5-a4f3-448c-8368-24080179bc53_ContentBits">
    <vt:lpwstr>0</vt:lpwstr>
  </property>
</Properties>
</file>